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7DFF5D2D-42A5-1AE2-D944-90C4547429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67229" y="3525838"/>
            <a:ext cx="10842171" cy="1655762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Forest plot of baseline serum phosphate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DC115E30-5E5A-253D-4169-94E179C5377B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14525" y="827315"/>
            <a:ext cx="8362950" cy="2501674"/>
            <a:chOff x="1124" y="843"/>
            <a:chExt cx="5268" cy="1254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AE62AB04-1EC9-5EAB-9F8E-6E925741636E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24" y="843"/>
              <a:ext cx="5268" cy="12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7D5ABC82-3603-940E-EB1E-C4EC25AD5C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4" y="843"/>
              <a:ext cx="5268" cy="1254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038F5267-DC25-18EE-D76D-86E7765AC7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24" y="1036"/>
              <a:ext cx="526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4FBFA02A-2501-C7D6-AE30-EA48387760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963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C076D900-B57F-DF5D-9899-BA339C3B72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070"/>
              <a:ext cx="2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Su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9733D9B3-864E-B70D-7A1C-58C330F61B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166"/>
              <a:ext cx="43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DE7B24BE-D26A-5A1E-651A-3E3DF222FE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263"/>
              <a:ext cx="35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lib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86C1D920-5946-5D1A-986B-AEF3178667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359"/>
              <a:ext cx="3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n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09EB9987-C340-61E9-718B-E25076E1D4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456"/>
              <a:ext cx="30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625262DF-5193-D193-A6D5-B7D5A613EB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552"/>
              <a:ext cx="32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ng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0506BF6E-7001-CFE9-BBEC-E092ACACF0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735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FE88F065-AE74-B425-7D8A-9CB09998A4E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840"/>
              <a:ext cx="254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0.01; Chi² = 39.39, df = 4 (P &lt; 0.00001); I² = 9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4180A752-3D07-1268-8DB3-54DC97079B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4" y="1938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2.12 (P = 0.03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06C93DB5-FB6D-7D89-A632-5F9ABFB828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7" y="963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AF9ED9AE-E1AB-8040-A873-36C6AA1D09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93" y="1070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FC46430D-6A03-A030-19AB-C4C857A1C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" y="11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9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F5365EDF-0C84-3829-037A-30D47B4E9C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" y="12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DE06AF5A-081F-B179-707E-9BB19E877A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" y="1359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DDF7BA3E-7E93-04D1-FD96-36175BE317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" y="145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F67EF305-1DCD-2040-A7FF-A0D27911A7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93" y="1552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8941D1E7-CFE5-9CA4-EF97-10F3461A3D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5" y="96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912ABADC-39EB-79F5-649C-64CE52803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107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9856E341-5786-2882-8896-BE3D998882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31" y="1166"/>
              <a:ext cx="14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CA5CD975-9790-7BFB-2619-8E280283B3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12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93E817CB-123E-2B5C-DAAF-E7EA15479F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1359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1A0FEEB7-E819-B7CD-6004-53F38370DC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91" y="145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31A84498-7781-F604-A549-95636AB6C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91" y="1552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70FACAF5-36FB-2775-D396-D7CC4A2362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91" y="963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8BB1B809-8F62-2C6B-6020-D0C47D29DD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070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11433C9F-87F8-39F6-7A47-8B291BEAD9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16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5BC5E3B2-F34D-0ABE-3DE7-4685881BDCA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263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FE9A871F-B07E-8708-ECD4-64C0F28309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359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CC548F0A-37E3-1BF9-5599-1E62E48158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9" y="1456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CF8A4EDD-8BF1-8A88-2239-BE795F8F25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9" y="1552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6551E9C7-2ABC-2965-ED40-1964CF69C5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4" y="1735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6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6294EE9D-61F2-0D0A-E34C-099B3E6896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14" y="963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218633D1-B085-787B-60B1-8380B87285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070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5EDEA0FA-D90E-A7A3-6885-4B12E17A8D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1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1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6AE82867-017C-C4E8-6231-16847C1A92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263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832199A2-B2A5-10FA-22D3-4BFE1B93BD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359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79C37257-8F6E-CBBA-3859-BAE5F7164D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456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4CE0C986-C240-239D-47C9-7E6D250B2E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0" y="1552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EB6CE562-C9FC-A525-F3D5-FD05FF05AF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38" y="963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F4FAE893-780D-3D90-5315-67503E491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07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375F1A87-BB44-87CA-3F38-2C25E98F0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16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9C3C67F9-49D0-2B72-44D0-DE56A259D5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263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237061C2-9249-C54E-42F9-092961668C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359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065DC3E3-7E77-F6E3-97B2-8D1D23AFC5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456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D07E441E-A2D4-51EE-B4B7-B6ED3F9F05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94" y="1552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1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361A9A20-4DF3-AEB7-11EA-7E9BC07777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00" y="963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5F592211-48B3-F6DF-1358-EA2170F0C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" y="107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1258920B-74BE-F5BB-D18D-8A5C391735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" y="116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24A79936-FF9E-A2A0-11FF-BE970A68AE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" y="1263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67956C18-11C5-AB63-972D-AFCDFB95D5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" y="1359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093B05B2-8FFE-ADC1-AC96-A590FB3A38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8" y="1456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BE74F395-F71D-18C5-F92A-FF4C5921B9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8" y="1552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9A448253-1F25-1511-1960-FC7208853A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42" y="1735"/>
              <a:ext cx="15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77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48E0C55B-3862-4EC2-6BF0-08B9A3BDCF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963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CFCA411C-7B00-F628-D291-7E5D0D2B15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4" y="107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4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3637C576-05C8-0560-6F4B-AA369810E8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4" y="1166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2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E5B5BEF6-F47B-1E8A-76C5-DD65F0ACD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4" y="1263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.8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3994A7BC-E2C1-AF12-A342-073367EC5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4" y="1359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9A6443DD-8123-987B-BB1F-449B9F6B24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4" y="1456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4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CAB2D07D-1353-44BF-A581-644EE95E12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29" y="1735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EA18D3A5-BC64-0894-CD7B-626C84D23B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9" y="963"/>
              <a:ext cx="70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3FD61DC5-6FC4-C159-428F-CD28A30C35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9" y="1070"/>
              <a:ext cx="62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4 [-0.37, -0.1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56068434-FD70-6603-D237-C36EE17A57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9" y="1166"/>
              <a:ext cx="68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1 [-0.28, -0.14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84A3EA4C-623C-1A7E-533B-B25D63084D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3" y="1263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7 [-0.24, 0.1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F68BE820-9BEA-E572-A71F-68F6E941F4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3" y="1359"/>
              <a:ext cx="6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06, 0.04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638250B1-13C6-544B-D4F0-506925DC30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3" y="1456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1 [-0.04, 0.0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50020F1A-CDFA-9F6E-BF2C-EB510AC0CA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1" y="1552"/>
              <a:ext cx="4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ot estimable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30290DCB-CAAA-E8BA-949E-63A7BB8077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95" y="1735"/>
              <a:ext cx="6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-0.10 [-0.19, -0.01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E61C1E91-C7D3-FFD0-3CDF-E709B8FE7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49" y="866"/>
              <a:ext cx="44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A0715ED3-3DEA-DA05-16AA-EF29DB45E0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65" y="866"/>
              <a:ext cx="62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075D6F0F-995A-A9B7-8D26-915DE2E231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6" y="866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44C5E71C-CC35-A09D-2B11-4C7CCCA3C0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2" y="866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4EB2CD78-0779-2103-2FBC-1D33CE384F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9" y="963"/>
              <a:ext cx="7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Line 81">
              <a:extLst>
                <a:ext uri="{FF2B5EF4-FFF2-40B4-BE49-F238E27FC236}">
                  <a16:creationId xmlns:a16="http://schemas.microsoft.com/office/drawing/2014/main" id="{2AA50D0C-2DF2-A6B2-9EDE-F4D1124629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4" y="1036"/>
              <a:ext cx="0" cy="82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id="{D380F409-FC2D-AB53-76BC-4E0B9E8A4B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96" y="1084"/>
              <a:ext cx="464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3A063326-54C4-9DD6-EAE8-7AD099022F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4" y="1076"/>
              <a:ext cx="28" cy="2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7" name="Line 84">
              <a:extLst>
                <a:ext uri="{FF2B5EF4-FFF2-40B4-BE49-F238E27FC236}">
                  <a16:creationId xmlns:a16="http://schemas.microsoft.com/office/drawing/2014/main" id="{16E5AC76-54C4-4E07-C043-0473E9EAE8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63" y="1181"/>
              <a:ext cx="23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id="{46081DF0-D975-277A-626E-7AE60A58B9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63" y="1170"/>
              <a:ext cx="34" cy="3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id="{F85AC25C-DBDB-96C2-5FA0-8DFDFDE9486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34" y="1277"/>
              <a:ext cx="57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0" name="Rectangle 87">
              <a:extLst>
                <a:ext uri="{FF2B5EF4-FFF2-40B4-BE49-F238E27FC236}">
                  <a16:creationId xmlns:a16="http://schemas.microsoft.com/office/drawing/2014/main" id="{8A0DA442-DE0D-6445-4F8F-6BFD19FDD6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0" y="1270"/>
              <a:ext cx="25" cy="26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1" name="Line 88">
              <a:extLst>
                <a:ext uri="{FF2B5EF4-FFF2-40B4-BE49-F238E27FC236}">
                  <a16:creationId xmlns:a16="http://schemas.microsoft.com/office/drawing/2014/main" id="{8B6434D5-B14D-95DC-FAFD-E0626E4436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33" y="1374"/>
              <a:ext cx="18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6838928B-62D6-250D-5C1C-8CA2523846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9" y="1362"/>
              <a:ext cx="35" cy="34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id="{783B6350-33C5-761A-441D-384A7C2FBF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83" y="1470"/>
              <a:ext cx="8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id="{8F490D65-4337-D972-8765-DA261B2BA5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8" y="1458"/>
              <a:ext cx="36" cy="36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Freeform 92">
              <a:extLst>
                <a:ext uri="{FF2B5EF4-FFF2-40B4-BE49-F238E27FC236}">
                  <a16:creationId xmlns:a16="http://schemas.microsoft.com/office/drawing/2014/main" id="{E5AE04CC-43FA-40D1-E5A7-01E5EF8A95C0}"/>
                </a:ext>
              </a:extLst>
            </p:cNvPr>
            <p:cNvSpPr>
              <a:spLocks/>
            </p:cNvSpPr>
            <p:nvPr/>
          </p:nvSpPr>
          <p:spPr bwMode="auto">
            <a:xfrm>
              <a:off x="5004" y="1717"/>
              <a:ext cx="325" cy="85"/>
            </a:xfrm>
            <a:custGeom>
              <a:avLst/>
              <a:gdLst>
                <a:gd name="T0" fmla="*/ 540 w 1080"/>
                <a:gd name="T1" fmla="*/ 280 h 280"/>
                <a:gd name="T2" fmla="*/ 0 w 1080"/>
                <a:gd name="T3" fmla="*/ 140 h 280"/>
                <a:gd name="T4" fmla="*/ 540 w 1080"/>
                <a:gd name="T5" fmla="*/ 0 h 280"/>
                <a:gd name="T6" fmla="*/ 1080 w 1080"/>
                <a:gd name="T7" fmla="*/ 140 h 280"/>
                <a:gd name="T8" fmla="*/ 540 w 108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80" h="280">
                  <a:moveTo>
                    <a:pt x="540" y="280"/>
                  </a:moveTo>
                  <a:lnTo>
                    <a:pt x="0" y="140"/>
                  </a:lnTo>
                  <a:lnTo>
                    <a:pt x="540" y="0"/>
                  </a:lnTo>
                  <a:lnTo>
                    <a:pt x="1080" y="140"/>
                  </a:lnTo>
                  <a:lnTo>
                    <a:pt x="54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Line 93">
              <a:extLst>
                <a:ext uri="{FF2B5EF4-FFF2-40B4-BE49-F238E27FC236}">
                  <a16:creationId xmlns:a16="http://schemas.microsoft.com/office/drawing/2014/main" id="{506DBEFB-412E-ABA3-F2AD-A70DEE2367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62" y="1856"/>
              <a:ext cx="196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D4F3ED62-23BB-52CC-80A6-3D05102947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78" y="183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180914AA-2908-1CD0-93F0-6427AAB4A43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6" y="1890"/>
              <a:ext cx="15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828BAD27-23B9-9607-B96D-23199F38E7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11" y="183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C1CD32C2-C842-EBC8-A44D-4F980E3FA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9" y="1890"/>
              <a:ext cx="1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1" name="Line 98">
              <a:extLst>
                <a:ext uri="{FF2B5EF4-FFF2-40B4-BE49-F238E27FC236}">
                  <a16:creationId xmlns:a16="http://schemas.microsoft.com/office/drawing/2014/main" id="{2B5D467D-3E7E-A1DE-3628-17F13DB32E9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44" y="183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77E33DAF-EEEA-D898-F342-C060C272F0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4" y="1890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3" name="Line 100">
              <a:extLst>
                <a:ext uri="{FF2B5EF4-FFF2-40B4-BE49-F238E27FC236}">
                  <a16:creationId xmlns:a16="http://schemas.microsoft.com/office/drawing/2014/main" id="{21FFE214-BCDB-0DF7-E27E-4D47CF0EC71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77" y="183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171DFA3B-1B5F-CCE2-438B-34C1AC50A6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07" y="1890"/>
              <a:ext cx="17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5" name="Line 102">
              <a:extLst>
                <a:ext uri="{FF2B5EF4-FFF2-40B4-BE49-F238E27FC236}">
                  <a16:creationId xmlns:a16="http://schemas.microsoft.com/office/drawing/2014/main" id="{0D94B833-3452-4638-8E88-5C271E36110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09" y="183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Rectangle 103">
              <a:extLst>
                <a:ext uri="{FF2B5EF4-FFF2-40B4-BE49-F238E27FC236}">
                  <a16:creationId xmlns:a16="http://schemas.microsoft.com/office/drawing/2014/main" id="{6D860E52-6866-B9DC-0015-5C508CAD98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60" y="1890"/>
              <a:ext cx="13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7" name="Rectangle 104">
              <a:extLst>
                <a:ext uri="{FF2B5EF4-FFF2-40B4-BE49-F238E27FC236}">
                  <a16:creationId xmlns:a16="http://schemas.microsoft.com/office/drawing/2014/main" id="{7D2729E6-43D8-7373-2DF4-F1A91EE216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41" y="1978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8" name="Rectangle 105">
              <a:extLst>
                <a:ext uri="{FF2B5EF4-FFF2-40B4-BE49-F238E27FC236}">
                  <a16:creationId xmlns:a16="http://schemas.microsoft.com/office/drawing/2014/main" id="{49B0D4FB-7531-09AD-A1D3-94E597DDEF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4" y="1978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609534517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5</Words>
  <Application>Microsoft Office PowerPoint</Application>
  <PresentationFormat>宽屏</PresentationFormat>
  <Paragraphs>8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7</cp:revision>
  <dcterms:created xsi:type="dcterms:W3CDTF">2023-08-09T12:44:00Z</dcterms:created>
  <dcterms:modified xsi:type="dcterms:W3CDTF">2026-02-06T15:58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